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3" r:id="rId4"/>
    <p:sldId id="262" r:id="rId5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8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857" autoAdjust="0"/>
  </p:normalViewPr>
  <p:slideViewPr>
    <p:cSldViewPr snapToGrid="0" showGuides="1">
      <p:cViewPr varScale="1">
        <p:scale>
          <a:sx n="83" d="100"/>
          <a:sy n="83" d="100"/>
        </p:scale>
        <p:origin x="3018" y="102"/>
      </p:cViewPr>
      <p:guideLst>
        <p:guide orient="horz" pos="318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543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9758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2721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49650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13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6942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5125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677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9522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8133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7027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61940-7493-430A-AC73-78F8BD5C5F6D}" type="datetimeFigureOut">
              <a:rPr lang="fr-FR" smtClean="0"/>
              <a:pPr/>
              <a:t>19/08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97F0C-23D8-4B7C-A00C-1521257F007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1134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18" Type="http://schemas.openxmlformats.org/officeDocument/2006/relationships/image" Target="../media/image9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" Type="http://schemas.openxmlformats.org/officeDocument/2006/relationships/image" Target="../media/image1.jpe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jpeg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13" Type="http://schemas.microsoft.com/office/2007/relationships/hdphoto" Target="../media/hdphoto13.wdp"/><Relationship Id="rId18" Type="http://schemas.openxmlformats.org/officeDocument/2006/relationships/image" Target="../media/image23.jpeg"/><Relationship Id="rId26" Type="http://schemas.microsoft.com/office/2007/relationships/hdphoto" Target="../media/hdphoto18.wdp"/><Relationship Id="rId3" Type="http://schemas.openxmlformats.org/officeDocument/2006/relationships/image" Target="../media/image13.png"/><Relationship Id="rId21" Type="http://schemas.openxmlformats.org/officeDocument/2006/relationships/image" Target="../media/image25.jpeg"/><Relationship Id="rId34" Type="http://schemas.microsoft.com/office/2007/relationships/hdphoto" Target="../media/hdphoto22.wdp"/><Relationship Id="rId7" Type="http://schemas.microsoft.com/office/2007/relationships/hdphoto" Target="../media/hdphoto10.wdp"/><Relationship Id="rId12" Type="http://schemas.openxmlformats.org/officeDocument/2006/relationships/image" Target="../media/image19.jpeg"/><Relationship Id="rId17" Type="http://schemas.openxmlformats.org/officeDocument/2006/relationships/image" Target="../media/image22.jpeg"/><Relationship Id="rId25" Type="http://schemas.openxmlformats.org/officeDocument/2006/relationships/image" Target="../media/image27.jpeg"/><Relationship Id="rId33" Type="http://schemas.openxmlformats.org/officeDocument/2006/relationships/image" Target="../media/image31.jpeg"/><Relationship Id="rId2" Type="http://schemas.openxmlformats.org/officeDocument/2006/relationships/image" Target="../media/image12.png"/><Relationship Id="rId16" Type="http://schemas.openxmlformats.org/officeDocument/2006/relationships/image" Target="../media/image21.jpeg"/><Relationship Id="rId20" Type="http://schemas.microsoft.com/office/2007/relationships/hdphoto" Target="../media/hdphoto15.wdp"/><Relationship Id="rId29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11" Type="http://schemas.microsoft.com/office/2007/relationships/hdphoto" Target="../media/hdphoto12.wdp"/><Relationship Id="rId24" Type="http://schemas.microsoft.com/office/2007/relationships/hdphoto" Target="../media/hdphoto17.wdp"/><Relationship Id="rId32" Type="http://schemas.microsoft.com/office/2007/relationships/hdphoto" Target="../media/hdphoto21.wdp"/><Relationship Id="rId5" Type="http://schemas.openxmlformats.org/officeDocument/2006/relationships/image" Target="../media/image15.png"/><Relationship Id="rId15" Type="http://schemas.microsoft.com/office/2007/relationships/hdphoto" Target="../media/hdphoto14.wdp"/><Relationship Id="rId23" Type="http://schemas.openxmlformats.org/officeDocument/2006/relationships/image" Target="../media/image26.jpeg"/><Relationship Id="rId28" Type="http://schemas.microsoft.com/office/2007/relationships/hdphoto" Target="../media/hdphoto19.wdp"/><Relationship Id="rId36" Type="http://schemas.microsoft.com/office/2007/relationships/hdphoto" Target="../media/hdphoto23.wdp"/><Relationship Id="rId10" Type="http://schemas.openxmlformats.org/officeDocument/2006/relationships/image" Target="../media/image18.jpeg"/><Relationship Id="rId19" Type="http://schemas.openxmlformats.org/officeDocument/2006/relationships/image" Target="../media/image24.jpeg"/><Relationship Id="rId31" Type="http://schemas.openxmlformats.org/officeDocument/2006/relationships/image" Target="../media/image30.jpeg"/><Relationship Id="rId4" Type="http://schemas.openxmlformats.org/officeDocument/2006/relationships/image" Target="../media/image14.png"/><Relationship Id="rId9" Type="http://schemas.microsoft.com/office/2007/relationships/hdphoto" Target="../media/hdphoto11.wdp"/><Relationship Id="rId14" Type="http://schemas.openxmlformats.org/officeDocument/2006/relationships/image" Target="../media/image20.jpeg"/><Relationship Id="rId22" Type="http://schemas.microsoft.com/office/2007/relationships/hdphoto" Target="../media/hdphoto16.wdp"/><Relationship Id="rId27" Type="http://schemas.openxmlformats.org/officeDocument/2006/relationships/image" Target="../media/image28.jpeg"/><Relationship Id="rId30" Type="http://schemas.microsoft.com/office/2007/relationships/hdphoto" Target="../media/hdphoto20.wdp"/><Relationship Id="rId35" Type="http://schemas.openxmlformats.org/officeDocument/2006/relationships/image" Target="../media/image32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e 36"/>
          <p:cNvGrpSpPr/>
          <p:nvPr/>
        </p:nvGrpSpPr>
        <p:grpSpPr>
          <a:xfrm>
            <a:off x="81313" y="49495"/>
            <a:ext cx="4816238" cy="4616221"/>
            <a:chOff x="81313" y="49495"/>
            <a:chExt cx="4816238" cy="4616221"/>
          </a:xfrm>
        </p:grpSpPr>
        <p:sp>
          <p:nvSpPr>
            <p:cNvPr id="3" name="Rectangle 2"/>
            <p:cNvSpPr/>
            <p:nvPr/>
          </p:nvSpPr>
          <p:spPr>
            <a:xfrm>
              <a:off x="2358239" y="4450272"/>
              <a:ext cx="155673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800" kern="1200" dirty="0" smtClean="0">
                  <a:effectLst/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BPMV-0</a:t>
              </a:r>
              <a:endParaRPr lang="fr-FR" sz="800" dirty="0">
                <a:effectLst/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3045808" y="4450272"/>
              <a:ext cx="185174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800" kern="1200" dirty="0">
                  <a:effectLst/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BPMV-GFP</a:t>
              </a:r>
              <a:endParaRPr lang="fr-FR" sz="800" dirty="0">
                <a:effectLst/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1579487" y="4450272"/>
              <a:ext cx="143813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800" dirty="0" err="1"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M</a:t>
              </a:r>
              <a:r>
                <a:rPr lang="fr-FR" sz="800" kern="1200" dirty="0" err="1" smtClean="0">
                  <a:effectLst/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ock</a:t>
              </a:r>
              <a:endParaRPr lang="fr-FR" sz="800" dirty="0">
                <a:effectLst/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pic>
          <p:nvPicPr>
            <p:cNvPr id="12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9553" t="28885" r="30143" b="24093"/>
            <a:stretch/>
          </p:blipFill>
          <p:spPr bwMode="auto">
            <a:xfrm>
              <a:off x="3591943" y="3255857"/>
              <a:ext cx="764541" cy="5977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5" name="Picture 5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-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9854" t="37669" r="42020" b="25068"/>
            <a:stretch/>
          </p:blipFill>
          <p:spPr bwMode="auto">
            <a:xfrm>
              <a:off x="3591943" y="2698626"/>
              <a:ext cx="764541" cy="5309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6" name="Picture 6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8776" t="26149" r="43942" b="43890"/>
            <a:stretch/>
          </p:blipFill>
          <p:spPr bwMode="auto">
            <a:xfrm>
              <a:off x="1879533" y="2698626"/>
              <a:ext cx="833028" cy="5309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7" name="Picture 7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8495" t="26216" r="35969" b="32582"/>
            <a:stretch/>
          </p:blipFill>
          <p:spPr bwMode="auto">
            <a:xfrm>
              <a:off x="1879531" y="3255857"/>
              <a:ext cx="835018" cy="5977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8" name="Picture 9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6440" t="26460" r="40979" b="34666"/>
            <a:stretch/>
          </p:blipFill>
          <p:spPr bwMode="auto">
            <a:xfrm>
              <a:off x="2749790" y="3260911"/>
              <a:ext cx="813617" cy="5876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9" name="Picture 8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22508" t="38061" r="34502" b="25078"/>
            <a:stretch/>
          </p:blipFill>
          <p:spPr bwMode="auto">
            <a:xfrm>
              <a:off x="2745361" y="2698626"/>
              <a:ext cx="813617" cy="5309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4" name="Image 23" descr="Image1.tif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colorTemperature colorTemp="53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2018108" y="3749162"/>
              <a:ext cx="581105" cy="833027"/>
            </a:xfrm>
            <a:prstGeom prst="rect">
              <a:avLst/>
            </a:prstGeom>
          </p:spPr>
        </p:pic>
        <p:pic>
          <p:nvPicPr>
            <p:cNvPr id="25" name="Image 24" descr="Image2.tif"/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colorTemperature colorTemp="53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2863831" y="3761077"/>
              <a:ext cx="581105" cy="809189"/>
            </a:xfrm>
            <a:prstGeom prst="rect">
              <a:avLst/>
            </a:prstGeom>
          </p:spPr>
        </p:pic>
        <p:pic>
          <p:nvPicPr>
            <p:cNvPr id="26" name="Image 25" descr="Image4.tif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 rot="5400000">
              <a:off x="3683428" y="3778273"/>
              <a:ext cx="581098" cy="774799"/>
            </a:xfrm>
            <a:prstGeom prst="rect">
              <a:avLst/>
            </a:prstGeom>
          </p:spPr>
        </p:pic>
        <p:sp>
          <p:nvSpPr>
            <p:cNvPr id="9" name="Rectangle 8"/>
            <p:cNvSpPr/>
            <p:nvPr/>
          </p:nvSpPr>
          <p:spPr>
            <a:xfrm>
              <a:off x="906782" y="2853138"/>
              <a:ext cx="118342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800" kern="1200" dirty="0" smtClean="0">
                  <a:effectLst/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Natural light</a:t>
              </a:r>
              <a:endParaRPr lang="fr-FR" sz="800" dirty="0">
                <a:effectLst/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157255" y="3433723"/>
              <a:ext cx="93295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800" kern="1200" dirty="0" smtClean="0">
                  <a:effectLst/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UV light</a:t>
              </a:r>
              <a:endParaRPr lang="fr-FR" sz="800" dirty="0">
                <a:effectLst/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157255" y="4086210"/>
              <a:ext cx="93295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800" kern="1200" dirty="0" smtClean="0">
                  <a:effectLst/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UV light</a:t>
              </a:r>
              <a:endParaRPr lang="fr-FR" sz="800" dirty="0">
                <a:effectLst/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81313" y="49495"/>
              <a:ext cx="20906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Figure S1	Pflieger et al.</a:t>
              </a:r>
              <a:r>
                <a:rPr lang="fr-FR" sz="12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endParaRPr lang="fr-FR" sz="1200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3" name="Groupe 12"/>
            <p:cNvGrpSpPr/>
            <p:nvPr/>
          </p:nvGrpSpPr>
          <p:grpSpPr>
            <a:xfrm>
              <a:off x="4152768" y="4389062"/>
              <a:ext cx="167883" cy="40938"/>
              <a:chOff x="4152768" y="4389062"/>
              <a:chExt cx="167883" cy="40938"/>
            </a:xfrm>
          </p:grpSpPr>
          <p:cxnSp>
            <p:nvCxnSpPr>
              <p:cNvPr id="6" name="Connecteur droit 5"/>
              <p:cNvCxnSpPr/>
              <p:nvPr/>
            </p:nvCxnSpPr>
            <p:spPr>
              <a:xfrm>
                <a:off x="4152768" y="4408538"/>
                <a:ext cx="167883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cteur droit 21"/>
              <p:cNvCxnSpPr/>
              <p:nvPr/>
            </p:nvCxnSpPr>
            <p:spPr>
              <a:xfrm>
                <a:off x="4159310" y="4389062"/>
                <a:ext cx="0" cy="40003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cteur droit 27"/>
              <p:cNvCxnSpPr/>
              <p:nvPr/>
            </p:nvCxnSpPr>
            <p:spPr>
              <a:xfrm>
                <a:off x="4316908" y="4389997"/>
                <a:ext cx="0" cy="40003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345058" y="4389997"/>
              <a:ext cx="167883" cy="40938"/>
              <a:chOff x="4152768" y="4389062"/>
              <a:chExt cx="167883" cy="40938"/>
            </a:xfrm>
          </p:grpSpPr>
          <p:cxnSp>
            <p:nvCxnSpPr>
              <p:cNvPr id="30" name="Connecteur droit 29"/>
              <p:cNvCxnSpPr/>
              <p:nvPr/>
            </p:nvCxnSpPr>
            <p:spPr>
              <a:xfrm>
                <a:off x="4152768" y="4408538"/>
                <a:ext cx="167883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30"/>
              <p:cNvCxnSpPr/>
              <p:nvPr/>
            </p:nvCxnSpPr>
            <p:spPr>
              <a:xfrm>
                <a:off x="4159310" y="4389062"/>
                <a:ext cx="0" cy="40003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31"/>
              <p:cNvCxnSpPr/>
              <p:nvPr/>
            </p:nvCxnSpPr>
            <p:spPr>
              <a:xfrm>
                <a:off x="4316908" y="4389997"/>
                <a:ext cx="0" cy="40003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2521350" y="4388069"/>
              <a:ext cx="167883" cy="40938"/>
              <a:chOff x="4152768" y="4389062"/>
              <a:chExt cx="167883" cy="40938"/>
            </a:xfrm>
          </p:grpSpPr>
          <p:cxnSp>
            <p:nvCxnSpPr>
              <p:cNvPr id="34" name="Connecteur droit 33"/>
              <p:cNvCxnSpPr/>
              <p:nvPr/>
            </p:nvCxnSpPr>
            <p:spPr>
              <a:xfrm>
                <a:off x="4152768" y="4408538"/>
                <a:ext cx="167883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34"/>
              <p:cNvCxnSpPr/>
              <p:nvPr/>
            </p:nvCxnSpPr>
            <p:spPr>
              <a:xfrm>
                <a:off x="4159310" y="4389062"/>
                <a:ext cx="0" cy="40003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cteur droit 35"/>
              <p:cNvCxnSpPr/>
              <p:nvPr/>
            </p:nvCxnSpPr>
            <p:spPr>
              <a:xfrm>
                <a:off x="4316908" y="4389997"/>
                <a:ext cx="0" cy="40003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26204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08418" y="37122"/>
            <a:ext cx="5634446" cy="3643856"/>
            <a:chOff x="108418" y="37122"/>
            <a:chExt cx="5634446" cy="3643856"/>
          </a:xfrm>
        </p:grpSpPr>
        <p:sp>
          <p:nvSpPr>
            <p:cNvPr id="3" name="ZoneTexte 2"/>
            <p:cNvSpPr txBox="1"/>
            <p:nvPr/>
          </p:nvSpPr>
          <p:spPr>
            <a:xfrm>
              <a:off x="3508031" y="1225191"/>
              <a:ext cx="8963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Black Valentine</a:t>
              </a:r>
              <a:endParaRPr lang="fr-FR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1738878" y="2424186"/>
              <a:ext cx="53412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SL </a:t>
              </a:r>
            </a:p>
            <a:p>
              <a:r>
                <a:rPr lang="fr-FR" sz="8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(21 dpi)</a:t>
              </a:r>
              <a:endParaRPr lang="fr-FR" sz="8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108418" y="37122"/>
              <a:ext cx="20906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Figure S2	Pflieger et al.</a:t>
              </a:r>
              <a:r>
                <a:rPr lang="fr-FR" sz="12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endParaRPr lang="fr-FR" sz="1200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6" name="Picture 3" descr="C:\Users\chouaib.meziadi\Desktop\Nouveau dossier (2)\IMG_0437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9065" r="36756" b="22768"/>
            <a:stretch/>
          </p:blipFill>
          <p:spPr bwMode="auto">
            <a:xfrm>
              <a:off x="2411760" y="1505949"/>
              <a:ext cx="1283492" cy="2175029"/>
            </a:xfrm>
            <a:prstGeom prst="rect">
              <a:avLst/>
            </a:prstGeom>
            <a:noFill/>
          </p:spPr>
        </p:pic>
        <p:pic>
          <p:nvPicPr>
            <p:cNvPr id="7" name="Picture 5" descr="C:\Users\chouaib.meziadi\Desktop\Nouveau dossier (2)\IMG_0431.JPG"/>
            <p:cNvPicPr>
              <a:picLocks noChangeAspect="1" noChangeArrowheads="1"/>
            </p:cNvPicPr>
            <p:nvPr/>
          </p:nvPicPr>
          <p:blipFill rotWithShape="1">
            <a:blip r:embed="rId4" cstate="print"/>
            <a:srcRect l="35514" t="28824" r="30021" b="18315"/>
            <a:stretch/>
          </p:blipFill>
          <p:spPr bwMode="auto">
            <a:xfrm>
              <a:off x="3851920" y="1505949"/>
              <a:ext cx="1890944" cy="2175029"/>
            </a:xfrm>
            <a:prstGeom prst="rect">
              <a:avLst/>
            </a:prstGeom>
            <a:noFill/>
          </p:spPr>
        </p:pic>
      </p:grpSp>
    </p:spTree>
    <p:extLst>
      <p:ext uri="{BB962C8B-B14F-4D97-AF65-F5344CB8AC3E}">
        <p14:creationId xmlns:p14="http://schemas.microsoft.com/office/powerpoint/2010/main" val="2329905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75012" y="2840320"/>
            <a:ext cx="796048" cy="1301452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027329" y="2840320"/>
            <a:ext cx="799435" cy="1301452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204568" y="2840320"/>
            <a:ext cx="799435" cy="130145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392382" y="2840320"/>
            <a:ext cx="799435" cy="1301452"/>
          </a:xfrm>
          <a:prstGeom prst="rect">
            <a:avLst/>
          </a:prstGeom>
        </p:spPr>
      </p:pic>
      <p:pic>
        <p:nvPicPr>
          <p:cNvPr id="6" name="Picture 2" descr="C:\Users\stephanie.pflieger\AppData\Local\Microsoft\Windows\Temporary Internet Files\Content.Word\IMG_072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 rot="5400000">
            <a:off x="1225426" y="1859757"/>
            <a:ext cx="1110259" cy="7966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3" descr="C:\Users\stephanie.pflieger\AppData\Local\Microsoft\Windows\Temporary Internet Files\Content.Word\IMG_0736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9474" r="5264" b="8696"/>
          <a:stretch>
            <a:fillRect/>
          </a:stretch>
        </p:blipFill>
        <p:spPr bwMode="auto">
          <a:xfrm rot="5400000">
            <a:off x="413137" y="1859756"/>
            <a:ext cx="1110259" cy="7966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4" descr="C:\Users\stephanie.pflieger\AppData\Local\Microsoft\Windows\Temporary Internet Files\Content.Word\IMG_0908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72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 rot="5400000">
            <a:off x="2047775" y="1859755"/>
            <a:ext cx="1110259" cy="7966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5" descr="C:\Users\stephanie.pflieger\AppData\Local\Microsoft\Windows\Temporary Internet Files\Content.Word\IMG_0892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r="8223"/>
          <a:stretch>
            <a:fillRect/>
          </a:stretch>
        </p:blipFill>
        <p:spPr bwMode="auto">
          <a:xfrm rot="5400000">
            <a:off x="2875611" y="1854682"/>
            <a:ext cx="1110258" cy="8068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ZoneTexte 9"/>
          <p:cNvSpPr txBox="1"/>
          <p:nvPr/>
        </p:nvSpPr>
        <p:spPr>
          <a:xfrm>
            <a:off x="508801" y="1486236"/>
            <a:ext cx="8963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lack Valentine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1455980" y="1486236"/>
            <a:ext cx="7537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JaloEEP558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2388937" y="1486236"/>
            <a:ext cx="5533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19833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262864" y="1486236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AT93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08418" y="2088814"/>
            <a:ext cx="4764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800">
                <a:latin typeface="Helvetica" panose="020B0604020202020204" pitchFamily="34" charset="0"/>
                <a:cs typeface="Helvetica" panose="020B0604020202020204" pitchFamily="34" charset="0"/>
              </a:defRPr>
            </a:lvl1pPr>
          </a:lstStyle>
          <a:p>
            <a:r>
              <a:rPr lang="fr-FR" dirty="0" smtClean="0"/>
              <a:t>IL </a:t>
            </a:r>
          </a:p>
          <a:p>
            <a:r>
              <a:rPr lang="fr-FR" dirty="0" smtClean="0"/>
              <a:t>(7 dpi</a:t>
            </a:r>
            <a:r>
              <a:rPr lang="fr-FR" dirty="0"/>
              <a:t>)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108418" y="3357836"/>
            <a:ext cx="5341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L </a:t>
            </a:r>
          </a:p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21 dpi)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6" name="Image 15" descr="jalo_4sem_uv.jpg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82219" y="4172882"/>
            <a:ext cx="796673" cy="1296954"/>
          </a:xfrm>
          <a:prstGeom prst="rect">
            <a:avLst/>
          </a:prstGeom>
        </p:spPr>
      </p:pic>
      <p:pic>
        <p:nvPicPr>
          <p:cNvPr id="17" name="Image 16" descr="g19_3+10_uv.jpg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2204568" y="4172882"/>
            <a:ext cx="799435" cy="1301452"/>
          </a:xfrm>
          <a:prstGeom prst="rect">
            <a:avLst/>
          </a:prstGeom>
        </p:spPr>
      </p:pic>
      <p:pic>
        <p:nvPicPr>
          <p:cNvPr id="18" name="Image 17" descr="bat_3+10_uv.jpg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3021896" y="4172882"/>
            <a:ext cx="796049" cy="1295938"/>
          </a:xfrm>
          <a:prstGeom prst="rect">
            <a:avLst/>
          </a:prstGeom>
        </p:spPr>
      </p:pic>
      <p:pic>
        <p:nvPicPr>
          <p:cNvPr id="19" name="Image 18" descr="bv_3+10_uv.jpg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575012" y="4172882"/>
            <a:ext cx="796048" cy="1295938"/>
          </a:xfrm>
          <a:prstGeom prst="rect">
            <a:avLst/>
          </a:prstGeom>
        </p:spPr>
      </p:pic>
      <p:sp>
        <p:nvSpPr>
          <p:cNvPr id="20" name="ZoneTexte 19"/>
          <p:cNvSpPr txBox="1"/>
          <p:nvPr/>
        </p:nvSpPr>
        <p:spPr>
          <a:xfrm>
            <a:off x="108418" y="4644212"/>
            <a:ext cx="5341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L </a:t>
            </a:r>
          </a:p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28 </a:t>
            </a:r>
            <a:r>
              <a:rPr lang="fr-FR" sz="800" dirty="0"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i)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1" name="Picture 2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colorTemperature colorTemp="5600"/>
                    </a14:imgEffect>
                    <a14:imgEffect>
                      <a14:saturation sat="20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34" t="9986" r="9594" b="6611"/>
          <a:stretch/>
        </p:blipFill>
        <p:spPr bwMode="auto">
          <a:xfrm rot="5400000">
            <a:off x="3771711" y="1784551"/>
            <a:ext cx="1108465" cy="9488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ZoneTexte 21"/>
          <p:cNvSpPr txBox="1"/>
          <p:nvPr/>
        </p:nvSpPr>
        <p:spPr>
          <a:xfrm>
            <a:off x="4148151" y="1486236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OR364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3" name="Picture 3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colorTemperature colorTemp="11500"/>
                    </a14:imgEffect>
                    <a14:imgEffect>
                      <a14:saturation sat="18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58"/>
          <a:stretch/>
        </p:blipFill>
        <p:spPr bwMode="auto">
          <a:xfrm rot="5400000">
            <a:off x="4758953" y="1773125"/>
            <a:ext cx="1112210" cy="9717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ZoneTexte 23"/>
          <p:cNvSpPr txBox="1"/>
          <p:nvPr/>
        </p:nvSpPr>
        <p:spPr>
          <a:xfrm>
            <a:off x="5114089" y="1486236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U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5" name="Picture 4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colorTemperature colorTemp="7200"/>
                    </a14:imgEffect>
                    <a14:imgEffect>
                      <a14:saturation sat="40000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319" t="15093" r="17320" b="6030"/>
          <a:stretch/>
        </p:blipFill>
        <p:spPr bwMode="auto">
          <a:xfrm rot="5400000">
            <a:off x="5728396" y="1804224"/>
            <a:ext cx="1110640" cy="9079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ZoneTexte 25"/>
          <p:cNvSpPr txBox="1"/>
          <p:nvPr/>
        </p:nvSpPr>
        <p:spPr>
          <a:xfrm>
            <a:off x="6154678" y="1486236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V</a:t>
            </a:r>
            <a:endParaRPr lang="fr-FR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7" name="Picture 2" descr="E:\DCIM\193___01\IMG_0178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colorTemperature colorTemp="7475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7642" t="28865" r="24238" b="4025"/>
          <a:stretch>
            <a:fillRect/>
          </a:stretch>
        </p:blipFill>
        <p:spPr bwMode="auto">
          <a:xfrm>
            <a:off x="3844871" y="2839115"/>
            <a:ext cx="970064" cy="1302163"/>
          </a:xfrm>
          <a:prstGeom prst="rect">
            <a:avLst/>
          </a:prstGeom>
          <a:noFill/>
        </p:spPr>
      </p:pic>
      <p:pic>
        <p:nvPicPr>
          <p:cNvPr id="28" name="Picture 3" descr="E:\DCIM\193___01\IMG_0181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colorTemperature colorTemp="7750"/>
                    </a14:imgEffect>
                  </a14:imgLayer>
                </a14:imgProps>
              </a:ext>
            </a:extLst>
          </a:blip>
          <a:srcRect l="29200" t="15952" r="32923" b="15076"/>
          <a:stretch>
            <a:fillRect/>
          </a:stretch>
        </p:blipFill>
        <p:spPr bwMode="auto">
          <a:xfrm>
            <a:off x="5832786" y="2846822"/>
            <a:ext cx="959153" cy="1295930"/>
          </a:xfrm>
          <a:prstGeom prst="rect">
            <a:avLst/>
          </a:prstGeom>
          <a:noFill/>
        </p:spPr>
      </p:pic>
      <p:pic>
        <p:nvPicPr>
          <p:cNvPr id="29" name="Picture 4" descr="E:\DCIM\193___01\IMG_0188.JP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colorTemperature colorTemp="8625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5435" t="24222" r="32923"/>
          <a:stretch>
            <a:fillRect/>
          </a:stretch>
        </p:blipFill>
        <p:spPr bwMode="auto">
          <a:xfrm>
            <a:off x="4846534" y="2839117"/>
            <a:ext cx="965435" cy="1312872"/>
          </a:xfrm>
          <a:prstGeom prst="rect">
            <a:avLst/>
          </a:prstGeom>
          <a:noFill/>
        </p:spPr>
      </p:pic>
      <p:pic>
        <p:nvPicPr>
          <p:cNvPr id="30" name="Picture 2" descr="E:\DCIM\193___01\IMG_0199.JPG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colorTemperature colorTemp="75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4527" t="42137" r="38589" b="11159"/>
          <a:stretch/>
        </p:blipFill>
        <p:spPr bwMode="auto">
          <a:xfrm>
            <a:off x="3851503" y="4171397"/>
            <a:ext cx="979620" cy="1290856"/>
          </a:xfrm>
          <a:prstGeom prst="rect">
            <a:avLst/>
          </a:prstGeom>
          <a:noFill/>
        </p:spPr>
      </p:pic>
      <p:pic>
        <p:nvPicPr>
          <p:cNvPr id="31" name="Picture 3" descr="E:\DCIM\193___01\IMG_0202.JPG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colorTemperature colorTemp="8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52157" t="46360" r="25234" b="14650"/>
          <a:stretch>
            <a:fillRect/>
          </a:stretch>
        </p:blipFill>
        <p:spPr bwMode="auto">
          <a:xfrm>
            <a:off x="5842894" y="4178743"/>
            <a:ext cx="978122" cy="1265038"/>
          </a:xfrm>
          <a:prstGeom prst="rect">
            <a:avLst/>
          </a:prstGeom>
          <a:noFill/>
        </p:spPr>
      </p:pic>
      <p:pic>
        <p:nvPicPr>
          <p:cNvPr id="32" name="Picture 4" descr="E:\DCIM\193___01\IMG_0203.JPG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colorTemperature colorTemp="75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6924" t="38509" r="31410" b="3118"/>
          <a:stretch/>
        </p:blipFill>
        <p:spPr bwMode="auto">
          <a:xfrm>
            <a:off x="4857356" y="4177354"/>
            <a:ext cx="964341" cy="1284899"/>
          </a:xfrm>
          <a:prstGeom prst="rect">
            <a:avLst/>
          </a:prstGeom>
          <a:noFill/>
        </p:spPr>
      </p:pic>
      <p:sp>
        <p:nvSpPr>
          <p:cNvPr id="33" name="ZoneTexte 32"/>
          <p:cNvSpPr txBox="1"/>
          <p:nvPr/>
        </p:nvSpPr>
        <p:spPr>
          <a:xfrm>
            <a:off x="108418" y="37122"/>
            <a:ext cx="20906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ure S3	Pflieger et al. </a:t>
            </a:r>
            <a:endParaRPr lang="fr-FR" sz="12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0322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 6"/>
          <p:cNvGrpSpPr/>
          <p:nvPr/>
        </p:nvGrpSpPr>
        <p:grpSpPr>
          <a:xfrm>
            <a:off x="108418" y="37122"/>
            <a:ext cx="6178280" cy="5296194"/>
            <a:chOff x="108418" y="37122"/>
            <a:chExt cx="6178280" cy="5296194"/>
          </a:xfrm>
        </p:grpSpPr>
        <p:sp>
          <p:nvSpPr>
            <p:cNvPr id="8" name="Rectangle 7"/>
            <p:cNvSpPr/>
            <p:nvPr/>
          </p:nvSpPr>
          <p:spPr>
            <a:xfrm>
              <a:off x="980728" y="1547664"/>
              <a:ext cx="5305970" cy="378565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m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CAAGGAATATTATGACCCAAACAAGTCTATGTTAGAGTTGGTTTTTGCACCAGCTGAAG 60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a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CAAGGAATATTATGACCCAAACAAGTCTATGTTAGAGTTGGTTTTTGCACCAGCTGAAG 60</a:t>
              </a:r>
            </a:p>
            <a:p>
              <a:r>
                <a:rPr lang="fr-FR" sz="8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mPDS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GCAAGGAATATTATAGCCCAAACCAGTCAATGTTAGAGTTGGTTTTTGCACCAGCCGAAG 60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   **************..*******.****:************************** ****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m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TGGATTTCACGTAGTGATGAAGATATCATTGAAGCCACAATGT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TGAGCTTGCCAAAC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120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a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TGGATTTCACGTAGTGATGAAGATATCATTGAAGCCACAATGT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TGAGCTTGCCAAAC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120</a:t>
              </a:r>
            </a:p>
            <a:p>
              <a:r>
                <a:rPr lang="fr-FR" sz="8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mPDS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AATGGATTTCACGTAGTGACGATGATATTATTCAAGCCACGATGA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TGAGCTTGCCAAAC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120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   ******************* **:***** *** *******.***: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***************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m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CTTTCCTGATGAAATTTCTGCAGACCAAAGCAAAGC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GATTGTCAAGTACCATGTTG 180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a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CTTTCCTGATGAAATTTCTGCAGACCAAAGCAAAGC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GATTGTCAAGTACCATGTTG 180</a:t>
              </a:r>
            </a:p>
            <a:p>
              <a:r>
                <a:rPr lang="fr-FR" sz="8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mPDS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CTTTCCTGATGAAATTTCTGCAGACCAAAGCAAAGC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AGATTCTCAAGTACCATGTTG 180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   </a:t>
              </a:r>
              <a:r>
                <a:rPr lang="fr-FR" sz="800" dirty="0">
                  <a:solidFill>
                    <a:schemeClr val="bg1">
                      <a:lumMod val="6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*************************************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:****** ***************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m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TAAAACACCAAGGTCGGTTTACAAAACCGTTCCAAATTGTGAACCTTGCCGTCCGGTAC 240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a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TAAAACACCAAGGTCGGTTTACAAAACCGTTCCAAATTGTGAACCTTGCCGTCCGCTAC 240</a:t>
              </a:r>
            </a:p>
            <a:p>
              <a:r>
                <a:rPr lang="fr-FR" sz="8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mPDS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TTAAAACACCAAGGTCGGTTTACAAAACTGTTCCAAATTGTGAACCTTGTCGACCCATTC 240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   **************************** ******************** **:**  *:*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m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GATCTCCTATTGAAGGTTTCTACTTAGCTGGAGATTACACAAAACAAAAATACTTAG 300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a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GATCTCCTATTGAAGGTTTCTACTTAGCTGGAGATTACACAAAACAAAAATATTTAG 300</a:t>
              </a:r>
            </a:p>
            <a:p>
              <a:r>
                <a:rPr lang="fr-FR" sz="8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mPDS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AAAGATCTCCTATAGAAGGTTTCTATTTAGCTGGAGATTACACAAAACAAAAATATTTAG 300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   *************:*********** ***************************** ****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m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CTTCAATGGAAGGTGCTGTTCTTTCCG 327</a:t>
              </a:r>
            </a:p>
            <a:p>
              <a:r>
                <a:rPr lang="fr-FR" sz="8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vaPDS</a:t>
              </a:r>
              <a:r>
                <a:rPr lang="fr-FR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CTTCAATGGAAGGTGCTGTTCTTTCTG 327</a:t>
              </a:r>
            </a:p>
            <a:p>
              <a:r>
                <a:rPr lang="fr-FR" sz="8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GmPDS</a:t>
              </a:r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CTTCAATGGAAGGCGCTGTTCTTTCTG 327</a:t>
              </a:r>
            </a:p>
            <a:p>
              <a:r>
                <a:rPr lang="fr-FR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               ************* *********** *</a:t>
              </a:r>
            </a:p>
            <a:p>
              <a:r>
                <a:rPr lang="en-US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  <a:endParaRPr lang="fr-FR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108418" y="37122"/>
              <a:ext cx="20473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Figure S4	</a:t>
              </a:r>
              <a:r>
                <a:rPr lang="fr-FR" sz="1200" i="1" dirty="0" err="1" smtClean="0">
                  <a:latin typeface="Helvetica" panose="020B0604020202020204" pitchFamily="34" charset="0"/>
                  <a:cs typeface="Helvetica" panose="020B0604020202020204" pitchFamily="34" charset="0"/>
                </a:rPr>
                <a:t>Pflieger</a:t>
              </a:r>
              <a:r>
                <a:rPr lang="fr-FR" sz="1200" i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 et al. </a:t>
              </a:r>
              <a:endParaRPr lang="fr-FR" sz="1200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2878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59</Words>
  <Application>Microsoft Office PowerPoint</Application>
  <PresentationFormat>Affichage à l'écran (4:3)</PresentationFormat>
  <Paragraphs>56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ourier New</vt:lpstr>
      <vt:lpstr>Helvetica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éphanie</dc:creator>
  <cp:lastModifiedBy>Stéphanie SP. Pflieger</cp:lastModifiedBy>
  <cp:revision>34</cp:revision>
  <dcterms:created xsi:type="dcterms:W3CDTF">2014-01-21T11:25:14Z</dcterms:created>
  <dcterms:modified xsi:type="dcterms:W3CDTF">2014-08-19T06:26:57Z</dcterms:modified>
</cp:coreProperties>
</file>